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89" d="100"/>
          <a:sy n="89" d="100"/>
        </p:scale>
        <p:origin x="51" y="30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A5CC67E-EB21-4C31-B4E7-55CD9E561F0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EB5B13BA-8D11-450E-9BCC-05E8C252AB7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EABEAC1-93FC-4425-AF6B-9F3CC1161B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62990-E28F-4516-8A83-AA64672FF75F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6F41E53-A738-44B5-B12D-A7C1150F03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7396386-6C5F-4CE5-AD32-2F054BDDEA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3713B-8083-4E63-A2CB-3BEDD59B5CE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01740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F9CE166-3B6D-483F-A2E3-2AC425F8EF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AEAF1EF2-09DF-4563-B8C5-07753C4486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8D31A14-7EFA-4D86-B8B5-4D043DD526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62990-E28F-4516-8A83-AA64672FF75F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4C6836D-45E3-45DA-9EC4-868DC832FC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0CC7470-DFAF-49BE-B762-1E1C844372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3713B-8083-4E63-A2CB-3BEDD59B5CE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6220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E137584A-CE3F-42D7-8844-6FB6F8877F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8BBC97E7-89DA-4243-A860-28AE02005D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50644BC-591A-48C8-A289-BBB2CC9B8A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62990-E28F-4516-8A83-AA64672FF75F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717B4FF-4EEF-4A76-A807-FDF2C8CC4E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EB22454-47A1-4F10-9679-16B116CD4F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3713B-8083-4E63-A2CB-3BEDD59B5CE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48283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D87ED90-3133-4CF5-9479-E97A11C016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FAE91A1-02F6-4C28-9053-7DB66F11942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807F0B5-FD39-4F6E-BF75-51AD39004F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62990-E28F-4516-8A83-AA64672FF75F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F3348AC-7C1E-4CAC-A4DE-8AA54778CF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72FB6C4-32F8-489B-ADD3-ED8FC141E4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3713B-8083-4E63-A2CB-3BEDD59B5CE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3188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91EB158-922A-4748-9C14-9523DA4E96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FFD97FEB-E7BA-4650-922B-50B5A504CF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CC4384B-5B56-48E1-A888-A817A83129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62990-E28F-4516-8A83-AA64672FF75F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A23B56B-DA9F-422C-910F-B5F57ECF8F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1703C94-763D-4935-B3F0-99516035D4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3713B-8083-4E63-A2CB-3BEDD59B5CE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0520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D2FE8DC-B089-4997-A809-B18D213006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33453F21-19B1-433B-A42A-712C40E8104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797DF5FD-65B9-49F9-944F-4C2699BAD7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FB2668E7-7CA5-4C8A-8A22-2AAC358C18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62990-E28F-4516-8A83-AA64672FF75F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CA1D2EF9-F8C9-40CE-A51E-38DF0325F8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B9FDAB8-312D-4E7A-B03E-8C34434F6F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3713B-8083-4E63-A2CB-3BEDD59B5CE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10389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9125023-F6D4-4136-B2D3-1B53240A8B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63F52FD-E117-4DF2-9919-DA53664E6B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65AB88C9-4BB8-4A3E-A29C-2147AFAC21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2B66CD6A-A265-45C5-A555-C636FD4F267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10BA81D8-91E0-4B86-B798-3AF0F63E39C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0F717FAC-D554-4F10-AA8C-8DDFC4211E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62990-E28F-4516-8A83-AA64672FF75F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5E3F95E3-0F78-4843-A3B6-38A8C7C620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83011BFA-8D64-42C7-A00B-2F3F4D7871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3713B-8083-4E63-A2CB-3BEDD59B5CE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62638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1F0092B-44E7-4F64-A020-05A6BD817D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0E5A49A0-FB2B-468F-A171-4A599A39D8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62990-E28F-4516-8A83-AA64672FF75F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E3E429AB-23EC-4AFB-B713-8D916D3703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90887489-C5BC-42A2-9626-CA773D0539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3713B-8083-4E63-A2CB-3BEDD59B5CE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1320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E573A92D-D15A-4A86-87DC-FCD61CCD76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62990-E28F-4516-8A83-AA64672FF75F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7B7AF7F4-10A3-42B6-91E5-6B2C9DC904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96B2E8F6-4F25-487B-900A-DB08278AD7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3713B-8083-4E63-A2CB-3BEDD59B5CE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261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503C85C-E9F8-462F-BEA5-C601E318E3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C595C87-CDD0-470E-96A3-8301BE856FB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F421B002-88B4-4BC9-9F3E-84EACA50C1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C088D65E-13ED-44F7-9A12-6BEEEFE936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62990-E28F-4516-8A83-AA64672FF75F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C467C2F6-BDBF-440E-9AA7-040A59A1AD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BDE81F21-2317-432E-BB96-BD816705CC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3713B-8083-4E63-A2CB-3BEDD59B5CE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27529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EA911DD-7179-4F3E-8D99-02B6D41276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A81EF222-2450-4C34-BF50-3979D4A9D72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1D921F9C-3F6D-4B8E-8E95-0C02EFF285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26B2C75F-E9CE-4078-9028-52ABAFFD47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62990-E28F-4516-8A83-AA64672FF75F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82756D73-C868-4BA6-834F-03CAF51225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4D21E4D9-83F5-4A28-B110-599DDC9220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3713B-8083-4E63-A2CB-3BEDD59B5CE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96089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8E7471A5-9074-4C3E-B055-4F957FD9F4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590C6678-DF89-4437-8804-FA20DE4B6A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665053F-31D8-4E1C-A724-000A775BA43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762990-E28F-4516-8A83-AA64672FF75F}" type="datetimeFigureOut">
              <a:rPr lang="en-US" smtClean="0"/>
              <a:t>9/9/2022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62BCBD9-7D06-47E8-B0C4-2123F2820CD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78F2CA0-A152-451D-8254-BD05E6B11B0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23713B-8083-4E63-A2CB-3BEDD59B5CE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70906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pieren 4">
            <a:extLst>
              <a:ext uri="{FF2B5EF4-FFF2-40B4-BE49-F238E27FC236}">
                <a16:creationId xmlns:a16="http://schemas.microsoft.com/office/drawing/2014/main" id="{E63B968F-0538-4C92-97F7-4012526FE3B8}"/>
              </a:ext>
            </a:extLst>
          </p:cNvPr>
          <p:cNvGrpSpPr/>
          <p:nvPr/>
        </p:nvGrpSpPr>
        <p:grpSpPr>
          <a:xfrm>
            <a:off x="621989" y="347738"/>
            <a:ext cx="7527831" cy="6303872"/>
            <a:chOff x="621989" y="347738"/>
            <a:chExt cx="7527831" cy="6303872"/>
          </a:xfrm>
        </p:grpSpPr>
        <p:pic>
          <p:nvPicPr>
            <p:cNvPr id="2" name="Grafik 1">
              <a:extLst>
                <a:ext uri="{FF2B5EF4-FFF2-40B4-BE49-F238E27FC236}">
                  <a16:creationId xmlns:a16="http://schemas.microsoft.com/office/drawing/2014/main" id="{0BA55339-092E-48DB-B29D-DE354BD7A7C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461038" y="3297968"/>
              <a:ext cx="3572264" cy="2842404"/>
            </a:xfrm>
            <a:prstGeom prst="rect">
              <a:avLst/>
            </a:prstGeom>
          </p:spPr>
        </p:pic>
        <p:pic>
          <p:nvPicPr>
            <p:cNvPr id="4" name="Grafik 3">
              <a:extLst>
                <a:ext uri="{FF2B5EF4-FFF2-40B4-BE49-F238E27FC236}">
                  <a16:creationId xmlns:a16="http://schemas.microsoft.com/office/drawing/2014/main" id="{D8FD48FF-BF32-46CE-B409-831957D258C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11219" y="347738"/>
              <a:ext cx="3552110" cy="2791304"/>
            </a:xfrm>
            <a:prstGeom prst="rect">
              <a:avLst/>
            </a:prstGeom>
          </p:spPr>
        </p:pic>
        <p:sp>
          <p:nvSpPr>
            <p:cNvPr id="6" name="Rechteck 5">
              <a:extLst>
                <a:ext uri="{FF2B5EF4-FFF2-40B4-BE49-F238E27FC236}">
                  <a16:creationId xmlns:a16="http://schemas.microsoft.com/office/drawing/2014/main" id="{F35B2EA1-6C1E-40BA-A5B3-E998E4DC9EC7}"/>
                </a:ext>
              </a:extLst>
            </p:cNvPr>
            <p:cNvSpPr/>
            <p:nvPr/>
          </p:nvSpPr>
          <p:spPr>
            <a:xfrm>
              <a:off x="621989" y="6189945"/>
              <a:ext cx="7527831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l Figure S1: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rrelation of L-EV</a:t>
              </a:r>
              <a:r>
                <a:rPr lang="en-US" sz="12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reg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/Mreg ratios with cell culture media characteristics at harvest. A. Mreg recovery. B. Glucose concentration. C. 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H.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D. Lactate concentration. </a:t>
              </a:r>
            </a:p>
          </p:txBody>
        </p:sp>
        <p:pic>
          <p:nvPicPr>
            <p:cNvPr id="14" name="Grafik 13">
              <a:extLst>
                <a:ext uri="{FF2B5EF4-FFF2-40B4-BE49-F238E27FC236}">
                  <a16:creationId xmlns:a16="http://schemas.microsoft.com/office/drawing/2014/main" id="{D13D0E79-08F9-4678-9D52-F14DA726EF3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414855" y="359136"/>
              <a:ext cx="3654034" cy="2791304"/>
            </a:xfrm>
            <a:prstGeom prst="rect">
              <a:avLst/>
            </a:prstGeom>
          </p:spPr>
        </p:pic>
        <p:pic>
          <p:nvPicPr>
            <p:cNvPr id="18" name="Grafik 17">
              <a:extLst>
                <a:ext uri="{FF2B5EF4-FFF2-40B4-BE49-F238E27FC236}">
                  <a16:creationId xmlns:a16="http://schemas.microsoft.com/office/drawing/2014/main" id="{D4DFA9EA-F3A3-40AA-B64D-492E97216D3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11220" y="3297967"/>
              <a:ext cx="3552109" cy="2856033"/>
            </a:xfrm>
            <a:prstGeom prst="rect">
              <a:avLst/>
            </a:prstGeom>
          </p:spPr>
        </p:pic>
        <p:sp>
          <p:nvSpPr>
            <p:cNvPr id="3" name="Textfeld 2">
              <a:extLst>
                <a:ext uri="{FF2B5EF4-FFF2-40B4-BE49-F238E27FC236}">
                  <a16:creationId xmlns:a16="http://schemas.microsoft.com/office/drawing/2014/main" id="{A93238FD-092B-452C-A5A0-B0718754A93B}"/>
                </a:ext>
              </a:extLst>
            </p:cNvPr>
            <p:cNvSpPr txBox="1"/>
            <p:nvPr/>
          </p:nvSpPr>
          <p:spPr>
            <a:xfrm>
              <a:off x="711220" y="347739"/>
              <a:ext cx="2776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/>
                <a:t>A</a:t>
              </a:r>
              <a:endParaRPr lang="en-US" sz="1200" b="1" dirty="0"/>
            </a:p>
          </p:txBody>
        </p:sp>
        <p:sp>
          <p:nvSpPr>
            <p:cNvPr id="9" name="Textfeld 8">
              <a:extLst>
                <a:ext uri="{FF2B5EF4-FFF2-40B4-BE49-F238E27FC236}">
                  <a16:creationId xmlns:a16="http://schemas.microsoft.com/office/drawing/2014/main" id="{2CBB7AFE-1998-466A-8A76-462EA6E4BD4A}"/>
                </a:ext>
              </a:extLst>
            </p:cNvPr>
            <p:cNvSpPr txBox="1"/>
            <p:nvPr/>
          </p:nvSpPr>
          <p:spPr>
            <a:xfrm>
              <a:off x="4407834" y="347738"/>
              <a:ext cx="2712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/>
                <a:t>B</a:t>
              </a:r>
              <a:endParaRPr lang="en-US" sz="1200" b="1" dirty="0"/>
            </a:p>
          </p:txBody>
        </p:sp>
        <p:sp>
          <p:nvSpPr>
            <p:cNvPr id="10" name="Textfeld 9">
              <a:extLst>
                <a:ext uri="{FF2B5EF4-FFF2-40B4-BE49-F238E27FC236}">
                  <a16:creationId xmlns:a16="http://schemas.microsoft.com/office/drawing/2014/main" id="{43EF87B7-C461-465C-B762-132682347655}"/>
                </a:ext>
              </a:extLst>
            </p:cNvPr>
            <p:cNvSpPr txBox="1"/>
            <p:nvPr/>
          </p:nvSpPr>
          <p:spPr>
            <a:xfrm>
              <a:off x="715239" y="3290500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/>
                <a:t>C</a:t>
              </a:r>
              <a:endParaRPr lang="en-US" sz="1200" b="1" dirty="0"/>
            </a:p>
          </p:txBody>
        </p:sp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id="{51B8088B-245D-47CE-8527-EC804A229497}"/>
                </a:ext>
              </a:extLst>
            </p:cNvPr>
            <p:cNvSpPr txBox="1"/>
            <p:nvPr/>
          </p:nvSpPr>
          <p:spPr>
            <a:xfrm>
              <a:off x="4420236" y="3297967"/>
              <a:ext cx="2824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/>
                <a:t>D</a:t>
              </a:r>
              <a:endParaRPr lang="en-US" sz="1200" b="1" dirty="0"/>
            </a:p>
          </p:txBody>
        </p:sp>
      </p:grpSp>
      <p:sp>
        <p:nvSpPr>
          <p:cNvPr id="7" name="Rechteck 6">
            <a:extLst>
              <a:ext uri="{FF2B5EF4-FFF2-40B4-BE49-F238E27FC236}">
                <a16:creationId xmlns:a16="http://schemas.microsoft.com/office/drawing/2014/main" id="{D838F302-D195-4C28-A0F1-665F104253E7}"/>
              </a:ext>
            </a:extLst>
          </p:cNvPr>
          <p:cNvSpPr/>
          <p:nvPr/>
        </p:nvSpPr>
        <p:spPr>
          <a:xfrm>
            <a:off x="668260" y="323190"/>
            <a:ext cx="7432464" cy="58812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2038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</Words>
  <Application>Microsoft Office PowerPoint</Application>
  <PresentationFormat>Breitbild</PresentationFormat>
  <Paragraphs>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Zitta, Karina Silvana</dc:creator>
  <cp:lastModifiedBy>Albrecht, Martin</cp:lastModifiedBy>
  <cp:revision>24</cp:revision>
  <dcterms:created xsi:type="dcterms:W3CDTF">2022-08-15T13:03:20Z</dcterms:created>
  <dcterms:modified xsi:type="dcterms:W3CDTF">2022-09-09T12:53:12Z</dcterms:modified>
</cp:coreProperties>
</file>